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9747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1868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9469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3375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366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5744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5136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5341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955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8231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1086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0788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905000" y="1828801"/>
          <a:ext cx="8534400" cy="228186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05948"/>
                <a:gridCol w="1374261"/>
                <a:gridCol w="1686992"/>
                <a:gridCol w="1295908"/>
                <a:gridCol w="1546688"/>
                <a:gridCol w="1424603"/>
              </a:tblGrid>
              <a:tr h="634904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4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O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</a:t>
                      </a:r>
                    </a:p>
                    <a:p>
                      <a:pPr marL="0" marR="0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Cases                control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Classified sample group  a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                              controls                 </a:t>
                      </a:r>
                      <a:r>
                        <a:rPr lang="en-US" sz="14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ct        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2134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36842</a:t>
                      </a:r>
                      <a:r>
                        <a:rPr lang="en-US" sz="14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2134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32924</a:t>
                      </a:r>
                      <a:r>
                        <a:rPr lang="en-US" sz="14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90527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16161</a:t>
                      </a:r>
                      <a:r>
                        <a:rPr lang="en-US" sz="14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10171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5667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310171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6012</a:t>
                      </a:r>
                      <a:r>
                        <a:rPr lang="en-GB" sz="140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2134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 fontAlgn="base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8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GB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752600" y="530425"/>
            <a:ext cx="8686800" cy="6155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143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just"/>
            <a:r>
              <a:rPr lang="en-US" altLang="en-US" sz="1400" b="1" dirty="0" err="1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altLang="en-US" sz="14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able. Classification </a:t>
            </a:r>
            <a:r>
              <a:rPr lang="en-US" altLang="en-US" sz="20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trix</a:t>
            </a:r>
            <a:r>
              <a:rPr lang="en-US" altLang="en-US" sz="14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AD samples based on 89 differentially regulated genes and using discriminant analysis Average accuracy, 98%, n= number of individuals in each study group</a:t>
            </a:r>
            <a:endParaRPr lang="en-US" altLang="en-US" sz="1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769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urwilo</dc:creator>
  <cp:lastModifiedBy>Douglas Surwilo</cp:lastModifiedBy>
  <cp:revision>1</cp:revision>
  <dcterms:created xsi:type="dcterms:W3CDTF">2015-12-11T19:46:02Z</dcterms:created>
  <dcterms:modified xsi:type="dcterms:W3CDTF">2015-12-11T19:46:15Z</dcterms:modified>
</cp:coreProperties>
</file>